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57" d="100"/>
          <a:sy n="57" d="100"/>
        </p:scale>
        <p:origin x="2688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ocuments\Sarah's%20paper\Ronke_caski%20overexpressing%20cells%20pifithrin%20+%20cisplatin%2024%20hours%2030081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ocuments\Sarah's%20paper\Ronke_caski%20overexpressing%20cells%20pifithrin%20+%20cisplatin%2024%20hours%20300818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ocuments\Sarah's%20paper\CaSki_GFP_CDDP_18.09.18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ocuments\Sarah's%20paper\CaSki_KpnB1-GFP_CDDP_18.09.18-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EGFP</a:t>
            </a:r>
          </a:p>
        </c:rich>
      </c:tx>
      <c:layout>
        <c:manualLayout>
          <c:xMode val="edge"/>
          <c:yMode val="edge"/>
          <c:x val="0.43262391114154208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8282028605120013"/>
          <c:y val="4.8445139210539861E-2"/>
          <c:w val="0.7499310548138004"/>
          <c:h val="0.73768398435489679"/>
        </c:manualLayout>
      </c:layout>
      <c:barChart>
        <c:barDir val="col"/>
        <c:grouping val="clustered"/>
        <c:varyColors val="0"/>
        <c:ser>
          <c:idx val="0"/>
          <c:order val="0"/>
          <c:tx>
            <c:v>-Pifithrin α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1!$K$12,Sheet1!$K$14,Sheet1!$K$15,Sheet1!$K$16)</c:f>
                <c:numCache>
                  <c:formatCode>General</c:formatCode>
                  <c:ptCount val="4"/>
                  <c:pt idx="0">
                    <c:v>7.0697083832627306E-3</c:v>
                  </c:pt>
                  <c:pt idx="1">
                    <c:v>2.1209125149788191E-2</c:v>
                  </c:pt>
                  <c:pt idx="2">
                    <c:v>3.6314233681278674E-2</c:v>
                  </c:pt>
                  <c:pt idx="3">
                    <c:v>4.770794141410367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Lit>
              <c:formatCode>General</c:formatCode>
              <c:ptCount val="4"/>
              <c:pt idx="0">
                <c:v>0</c:v>
              </c:pt>
              <c:pt idx="1">
                <c:v>10</c:v>
              </c:pt>
              <c:pt idx="2">
                <c:v>20</c:v>
              </c:pt>
              <c:pt idx="3">
                <c:v>30</c:v>
              </c:pt>
            </c:numLit>
          </c:cat>
          <c:val>
            <c:numRef>
              <c:f>(Sheet1!$J$12,Sheet1!$J$14,Sheet1!$J$15,Sheet1!$J$16)</c:f>
              <c:numCache>
                <c:formatCode>0.000</c:formatCode>
                <c:ptCount val="4"/>
                <c:pt idx="0">
                  <c:v>1.0019607843137255</c:v>
                </c:pt>
                <c:pt idx="1">
                  <c:v>0.95294117647058818</c:v>
                </c:pt>
                <c:pt idx="2">
                  <c:v>0.75098039215686274</c:v>
                </c:pt>
                <c:pt idx="3">
                  <c:v>0.703921568627450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5F-40E4-80C7-75727D9EC4B7}"/>
            </c:ext>
          </c:extLst>
        </c:ser>
        <c:ser>
          <c:idx val="1"/>
          <c:order val="1"/>
          <c:tx>
            <c:v>+Pifithrin α</c:v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1!$K$13,Sheet1!$K$17,Sheet1!$K$18,Sheet1!$K$19)</c:f>
                <c:numCache>
                  <c:formatCode>General</c:formatCode>
                  <c:ptCount val="4"/>
                  <c:pt idx="0">
                    <c:v>9.0004058176694143E-2</c:v>
                  </c:pt>
                  <c:pt idx="1">
                    <c:v>1.5563243006262311E-2</c:v>
                  </c:pt>
                  <c:pt idx="2">
                    <c:v>5.3049997092034035E-2</c:v>
                  </c:pt>
                  <c:pt idx="3">
                    <c:v>1.604971131739697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Lit>
              <c:formatCode>General</c:formatCode>
              <c:ptCount val="4"/>
              <c:pt idx="0">
                <c:v>0</c:v>
              </c:pt>
              <c:pt idx="1">
                <c:v>10</c:v>
              </c:pt>
              <c:pt idx="2">
                <c:v>20</c:v>
              </c:pt>
              <c:pt idx="3">
                <c:v>30</c:v>
              </c:pt>
            </c:numLit>
          </c:cat>
          <c:val>
            <c:numRef>
              <c:f>(Sheet1!$J$13,Sheet1!$J$17,Sheet1!$J$18,Sheet1!$J$19)</c:f>
              <c:numCache>
                <c:formatCode>0.000</c:formatCode>
                <c:ptCount val="4"/>
                <c:pt idx="0">
                  <c:v>1.3960784313725487</c:v>
                </c:pt>
                <c:pt idx="1">
                  <c:v>1.1529411764705881</c:v>
                </c:pt>
                <c:pt idx="2">
                  <c:v>0.85294117647058831</c:v>
                </c:pt>
                <c:pt idx="3">
                  <c:v>0.74313725490196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75F-40E4-80C7-75727D9EC4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4391168"/>
        <c:axId val="205345536"/>
      </c:barChart>
      <c:catAx>
        <c:axId val="2043911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onc. Cisplatin (µM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205345536"/>
        <c:crosses val="autoZero"/>
        <c:auto val="1"/>
        <c:lblAlgn val="ctr"/>
        <c:lblOffset val="100"/>
        <c:noMultiLvlLbl val="0"/>
      </c:catAx>
      <c:valAx>
        <c:axId val="2053455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cell number</a:t>
                </a:r>
              </a:p>
            </c:rich>
          </c:tx>
          <c:overlay val="0"/>
        </c:title>
        <c:numFmt formatCode="0.0" sourceLinked="0"/>
        <c:majorTickMark val="out"/>
        <c:minorTickMark val="none"/>
        <c:tickLblPos val="nextTo"/>
        <c:crossAx val="2043911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4929105329225156"/>
          <c:y val="3.5277420291546097E-3"/>
          <c:w val="0.35070894670774849"/>
          <c:h val="0.2110332222509640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Kpn</a:t>
            </a:r>
            <a:r>
              <a:rPr lang="el-GR"/>
              <a:t>β1-</a:t>
            </a:r>
            <a:r>
              <a:rPr lang="en-US"/>
              <a:t>EGFP</a:t>
            </a:r>
          </a:p>
        </c:rich>
      </c:tx>
      <c:layout>
        <c:manualLayout>
          <c:xMode val="edge"/>
          <c:yMode val="edge"/>
          <c:x val="0.32214662025942409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7678163870820496"/>
          <c:y val="4.027520457001698E-2"/>
          <c:w val="0.7559697021567956"/>
          <c:h val="0.73884964747053672"/>
        </c:manualLayout>
      </c:layout>
      <c:barChart>
        <c:barDir val="col"/>
        <c:grouping val="clustered"/>
        <c:varyColors val="0"/>
        <c:ser>
          <c:idx val="0"/>
          <c:order val="0"/>
          <c:tx>
            <c:v>-Pifithrin α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1!$K$23,Sheet1!$K$25,Sheet1!$K$26,Sheet1!$K$27)</c:f>
                <c:numCache>
                  <c:formatCode>General</c:formatCode>
                  <c:ptCount val="4"/>
                  <c:pt idx="0">
                    <c:v>3.5879248650843534E-2</c:v>
                  </c:pt>
                  <c:pt idx="1">
                    <c:v>5.3718199883654297E-2</c:v>
                  </c:pt>
                  <c:pt idx="2">
                    <c:v>4.6489581404206316E-2</c:v>
                  </c:pt>
                  <c:pt idx="3">
                    <c:v>2.405626121623437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Lit>
              <c:formatCode>General</c:formatCode>
              <c:ptCount val="4"/>
              <c:pt idx="0">
                <c:v>0</c:v>
              </c:pt>
              <c:pt idx="1">
                <c:v>10</c:v>
              </c:pt>
              <c:pt idx="2">
                <c:v>20</c:v>
              </c:pt>
              <c:pt idx="3">
                <c:v>30</c:v>
              </c:pt>
            </c:numLit>
          </c:cat>
          <c:val>
            <c:numRef>
              <c:f>(Sheet1!$J$23,Sheet1!$J$25,Sheet1!$J$26,Sheet1!$J$27)</c:f>
              <c:numCache>
                <c:formatCode>0.000</c:formatCode>
                <c:ptCount val="4"/>
                <c:pt idx="0">
                  <c:v>1</c:v>
                </c:pt>
                <c:pt idx="1">
                  <c:v>0.87301587301587291</c:v>
                </c:pt>
                <c:pt idx="2">
                  <c:v>0.72023809523809512</c:v>
                </c:pt>
                <c:pt idx="3">
                  <c:v>0.624999999999999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C9-4CF5-92C1-56AC00B1057C}"/>
            </c:ext>
          </c:extLst>
        </c:ser>
        <c:ser>
          <c:idx val="1"/>
          <c:order val="1"/>
          <c:tx>
            <c:v>+Pifithrin α</c:v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1!$K$24,Sheet1!$K$28,Sheet1!$K$29,Sheet1!$K$30)</c:f>
                <c:numCache>
                  <c:formatCode>General</c:formatCode>
                  <c:ptCount val="4"/>
                  <c:pt idx="0">
                    <c:v>6.7606051735717598E-2</c:v>
                  </c:pt>
                  <c:pt idx="1">
                    <c:v>8.5731736906620212E-2</c:v>
                  </c:pt>
                  <c:pt idx="2">
                    <c:v>6.7693341703302073E-2</c:v>
                  </c:pt>
                  <c:pt idx="3">
                    <c:v>3.278315801956015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Lit>
              <c:formatCode>General</c:formatCode>
              <c:ptCount val="4"/>
              <c:pt idx="0">
                <c:v>0</c:v>
              </c:pt>
              <c:pt idx="1">
                <c:v>10</c:v>
              </c:pt>
              <c:pt idx="2">
                <c:v>20</c:v>
              </c:pt>
              <c:pt idx="3">
                <c:v>30</c:v>
              </c:pt>
            </c:numLit>
          </c:cat>
          <c:val>
            <c:numRef>
              <c:f>(Sheet1!$J$24,Sheet1!$J$28,Sheet1!$J$29,Sheet1!$J$30)</c:f>
              <c:numCache>
                <c:formatCode>0.000</c:formatCode>
                <c:ptCount val="4"/>
                <c:pt idx="0">
                  <c:v>1.3392857142857142</c:v>
                </c:pt>
                <c:pt idx="1">
                  <c:v>1.2222222222222221</c:v>
                </c:pt>
                <c:pt idx="2">
                  <c:v>0.95238095238095233</c:v>
                </c:pt>
                <c:pt idx="3">
                  <c:v>0.73214285714285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DC9-4CF5-92C1-56AC00B105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074496"/>
        <c:axId val="42076416"/>
      </c:barChart>
      <c:catAx>
        <c:axId val="420744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onc. Cisplatin (µM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2076416"/>
        <c:crosses val="autoZero"/>
        <c:auto val="1"/>
        <c:lblAlgn val="ctr"/>
        <c:lblOffset val="100"/>
        <c:noMultiLvlLbl val="0"/>
      </c:catAx>
      <c:valAx>
        <c:axId val="420764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cell number</a:t>
                </a:r>
              </a:p>
            </c:rich>
          </c:tx>
          <c:overlay val="0"/>
        </c:title>
        <c:numFmt formatCode="0.0" sourceLinked="0"/>
        <c:majorTickMark val="out"/>
        <c:minorTickMark val="none"/>
        <c:tickLblPos val="nextTo"/>
        <c:crossAx val="420744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8552293735022252"/>
          <c:y val="3.5277420291546097E-3"/>
          <c:w val="0.31447706264977748"/>
          <c:h val="0.2110332222509640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EGFP</a:t>
            </a:r>
          </a:p>
        </c:rich>
      </c:tx>
      <c:layout>
        <c:manualLayout>
          <c:xMode val="edge"/>
          <c:yMode val="edge"/>
          <c:x val="0.43262391114154208"/>
          <c:y val="8.1699346405228763E-3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8017564380539389"/>
          <c:y val="5.1400554097404488E-2"/>
          <c:w val="0.78783902012248463"/>
          <c:h val="0.73444808982210552"/>
        </c:manualLayout>
      </c:layout>
      <c:barChart>
        <c:barDir val="col"/>
        <c:grouping val="clustered"/>
        <c:varyColors val="0"/>
        <c:ser>
          <c:idx val="0"/>
          <c:order val="0"/>
          <c:tx>
            <c:v>ctl siRNA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C$14:$F$14</c:f>
                <c:numCache>
                  <c:formatCode>General</c:formatCode>
                  <c:ptCount val="4"/>
                  <c:pt idx="0">
                    <c:v>2.8205081957437809E-2</c:v>
                  </c:pt>
                  <c:pt idx="1">
                    <c:v>2.4874544189191796E-2</c:v>
                  </c:pt>
                  <c:pt idx="2">
                    <c:v>2.3161921996687602E-2</c:v>
                  </c:pt>
                  <c:pt idx="3">
                    <c:v>2.324606399834829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Lit>
              <c:formatCode>General</c:formatCode>
              <c:ptCount val="4"/>
              <c:pt idx="0">
                <c:v>0</c:v>
              </c:pt>
              <c:pt idx="1">
                <c:v>10</c:v>
              </c:pt>
              <c:pt idx="2">
                <c:v>20</c:v>
              </c:pt>
              <c:pt idx="3">
                <c:v>30</c:v>
              </c:pt>
            </c:numLit>
          </c:cat>
          <c:val>
            <c:numRef>
              <c:f>Sheet1!$C$13:$F$13</c:f>
              <c:numCache>
                <c:formatCode>General</c:formatCode>
                <c:ptCount val="4"/>
                <c:pt idx="0">
                  <c:v>1.0000000000000004</c:v>
                </c:pt>
                <c:pt idx="1">
                  <c:v>0.924060751398881</c:v>
                </c:pt>
                <c:pt idx="2">
                  <c:v>0.83413269384492439</c:v>
                </c:pt>
                <c:pt idx="3">
                  <c:v>0.835464961364242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1B-472A-872D-1A3A251A8EF7}"/>
            </c:ext>
          </c:extLst>
        </c:ser>
        <c:ser>
          <c:idx val="1"/>
          <c:order val="1"/>
          <c:tx>
            <c:v>p21 siRNA</c:v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G$14:$J$14</c:f>
                <c:numCache>
                  <c:formatCode>General</c:formatCode>
                  <c:ptCount val="4"/>
                  <c:pt idx="0">
                    <c:v>1.5260134360006788E-2</c:v>
                  </c:pt>
                  <c:pt idx="1">
                    <c:v>5.9333787026968801E-2</c:v>
                  </c:pt>
                  <c:pt idx="2">
                    <c:v>6.6123968217119369E-2</c:v>
                  </c:pt>
                  <c:pt idx="3">
                    <c:v>4.117223987628369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Lit>
              <c:formatCode>General</c:formatCode>
              <c:ptCount val="4"/>
              <c:pt idx="0">
                <c:v>0</c:v>
              </c:pt>
              <c:pt idx="1">
                <c:v>10</c:v>
              </c:pt>
              <c:pt idx="2">
                <c:v>20</c:v>
              </c:pt>
              <c:pt idx="3">
                <c:v>30</c:v>
              </c:pt>
            </c:numLit>
          </c:cat>
          <c:val>
            <c:numRef>
              <c:f>Sheet1!$G$13:$J$13</c:f>
              <c:numCache>
                <c:formatCode>General</c:formatCode>
                <c:ptCount val="4"/>
                <c:pt idx="0">
                  <c:v>1.1132427391420199</c:v>
                </c:pt>
                <c:pt idx="1">
                  <c:v>0.9100719424460435</c:v>
                </c:pt>
                <c:pt idx="2">
                  <c:v>0.74287236877164942</c:v>
                </c:pt>
                <c:pt idx="3">
                  <c:v>0.626298960831334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B1B-472A-872D-1A3A251A8E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131840"/>
        <c:axId val="42133760"/>
      </c:barChart>
      <c:catAx>
        <c:axId val="421318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onc. Cisplatin (µM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2133760"/>
        <c:crosses val="autoZero"/>
        <c:auto val="1"/>
        <c:lblAlgn val="ctr"/>
        <c:lblOffset val="100"/>
        <c:noMultiLvlLbl val="0"/>
      </c:catAx>
      <c:valAx>
        <c:axId val="421337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cell number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21318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8395669291338579"/>
          <c:y val="1.3505030621172356E-2"/>
          <c:w val="0.28114325383240141"/>
          <c:h val="0.1674343832020997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Kpn</a:t>
            </a:r>
            <a:r>
              <a:rPr lang="el-GR"/>
              <a:t>β1-</a:t>
            </a:r>
            <a:r>
              <a:rPr lang="en-US"/>
              <a:t>EGFP</a:t>
            </a:r>
          </a:p>
        </c:rich>
      </c:tx>
      <c:layout>
        <c:manualLayout>
          <c:xMode val="edge"/>
          <c:yMode val="edge"/>
          <c:x val="0.32818526760241928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8017564380539389"/>
          <c:y val="5.1400554097404488E-2"/>
          <c:w val="0.7822834645669291"/>
          <c:h val="0.73444808982210552"/>
        </c:manualLayout>
      </c:layout>
      <c:barChart>
        <c:barDir val="col"/>
        <c:grouping val="clustered"/>
        <c:varyColors val="0"/>
        <c:ser>
          <c:idx val="0"/>
          <c:order val="0"/>
          <c:tx>
            <c:v>ctl siRNA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C$14:$F$14</c:f>
                <c:numCache>
                  <c:formatCode>General</c:formatCode>
                  <c:ptCount val="4"/>
                  <c:pt idx="0">
                    <c:v>1.9873363503842348E-2</c:v>
                  </c:pt>
                  <c:pt idx="1">
                    <c:v>1.8064780148309111E-2</c:v>
                  </c:pt>
                  <c:pt idx="2">
                    <c:v>3.7554739636868548E-2</c:v>
                  </c:pt>
                  <c:pt idx="3">
                    <c:v>1.886905538303719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Lit>
              <c:formatCode>General</c:formatCode>
              <c:ptCount val="4"/>
              <c:pt idx="0">
                <c:v>0</c:v>
              </c:pt>
              <c:pt idx="1">
                <c:v>10</c:v>
              </c:pt>
              <c:pt idx="2">
                <c:v>20</c:v>
              </c:pt>
              <c:pt idx="3">
                <c:v>30</c:v>
              </c:pt>
            </c:numLit>
          </c:cat>
          <c:val>
            <c:numRef>
              <c:f>Sheet1!$C$13:$F$13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0.99725576289791451</c:v>
                </c:pt>
                <c:pt idx="2">
                  <c:v>0.78183315038419299</c:v>
                </c:pt>
                <c:pt idx="3">
                  <c:v>0.78732162458836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E1-45E3-BC2B-2644038AA738}"/>
            </c:ext>
          </c:extLst>
        </c:ser>
        <c:ser>
          <c:idx val="1"/>
          <c:order val="1"/>
          <c:tx>
            <c:v>p21 siRNA</c:v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G$14:$J$14</c:f>
                <c:numCache>
                  <c:formatCode>General</c:formatCode>
                  <c:ptCount val="4"/>
                  <c:pt idx="0">
                    <c:v>4.3500943146449512E-2</c:v>
                  </c:pt>
                  <c:pt idx="1">
                    <c:v>8.9055086365691483E-2</c:v>
                  </c:pt>
                  <c:pt idx="2">
                    <c:v>0.11285715629492769</c:v>
                  </c:pt>
                  <c:pt idx="3">
                    <c:v>0.135892855336936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Lit>
              <c:formatCode>General</c:formatCode>
              <c:ptCount val="4"/>
              <c:pt idx="0">
                <c:v>0</c:v>
              </c:pt>
              <c:pt idx="1">
                <c:v>10</c:v>
              </c:pt>
              <c:pt idx="2">
                <c:v>20</c:v>
              </c:pt>
              <c:pt idx="3">
                <c:v>30</c:v>
              </c:pt>
            </c:numLit>
          </c:cat>
          <c:val>
            <c:numRef>
              <c:f>Sheet1!$G$13:$J$13</c:f>
              <c:numCache>
                <c:formatCode>General</c:formatCode>
                <c:ptCount val="4"/>
                <c:pt idx="0">
                  <c:v>1.0809549945115258</c:v>
                </c:pt>
                <c:pt idx="1">
                  <c:v>0.86553238199780469</c:v>
                </c:pt>
                <c:pt idx="2">
                  <c:v>0.47447859495060379</c:v>
                </c:pt>
                <c:pt idx="3">
                  <c:v>0.342755214050493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EE1-45E3-BC2B-2644038AA7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168704"/>
        <c:axId val="42170624"/>
      </c:barChart>
      <c:catAx>
        <c:axId val="421687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onc. Cisplatin (µM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2170624"/>
        <c:crosses val="autoZero"/>
        <c:auto val="1"/>
        <c:lblAlgn val="ctr"/>
        <c:lblOffset val="100"/>
        <c:noMultiLvlLbl val="0"/>
      </c:catAx>
      <c:valAx>
        <c:axId val="421706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cell number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216870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8547206055764764"/>
          <c:y val="3.6653178769320505E-2"/>
          <c:w val="0.28952793944235233"/>
          <c:h val="0.1840467551850136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251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742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15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570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995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07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363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08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058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28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241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EC3889-1716-4D16-8F77-F7C190734C6B}" type="datetimeFigureOut">
              <a:rPr lang="en-US" smtClean="0"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631C12-13FE-47BC-989A-062D1823A8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903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6714602"/>
              </p:ext>
            </p:extLst>
          </p:nvPr>
        </p:nvGraphicFramePr>
        <p:xfrm>
          <a:off x="609600" y="1600200"/>
          <a:ext cx="210312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067707"/>
              </p:ext>
            </p:extLst>
          </p:nvPr>
        </p:nvGraphicFramePr>
        <p:xfrm>
          <a:off x="619125" y="3352800"/>
          <a:ext cx="210312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114425" y="160972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14475" y="184195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114425" y="341947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524000" y="349567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914525" y="368980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333625" y="383857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5129294"/>
              </p:ext>
            </p:extLst>
          </p:nvPr>
        </p:nvGraphicFramePr>
        <p:xfrm>
          <a:off x="3810000" y="1600200"/>
          <a:ext cx="210312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0469665"/>
              </p:ext>
            </p:extLst>
          </p:nvPr>
        </p:nvGraphicFramePr>
        <p:xfrm>
          <a:off x="3886200" y="3352800"/>
          <a:ext cx="2103120" cy="1554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5562600" y="203177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229225" y="387667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638800" y="396603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28600" y="12192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505200" y="127191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45431" y="1600200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39821" y="331100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519626" y="1600200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514016" y="331100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768788" y="383327"/>
            <a:ext cx="29419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2877530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62</Words>
  <Application>Microsoft Office PowerPoint</Application>
  <PresentationFormat>A4 Paper (210x297 mm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ine van der Watt</dc:creator>
  <cp:lastModifiedBy>Virna Leaner</cp:lastModifiedBy>
  <cp:revision>9</cp:revision>
  <dcterms:created xsi:type="dcterms:W3CDTF">2018-09-18T10:45:07Z</dcterms:created>
  <dcterms:modified xsi:type="dcterms:W3CDTF">2018-09-21T10:17:25Z</dcterms:modified>
</cp:coreProperties>
</file>